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422" r:id="rId3"/>
    <p:sldId id="425" r:id="rId4"/>
    <p:sldId id="42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25C3BB6-B3D3-4916-B4A6-0675C088200E}" v="1" dt="2024-07-19T20:05:40.6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DE5DD-E0F6-8AB9-BFAB-16BDEC0AB5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3E3E86-E404-9712-8000-F2C44700CF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FB3EE4-9625-3573-77BF-C084E42AB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F8762A-7566-E37E-A81F-19C41F7C4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891E75-D058-0169-F987-A8209441D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79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E3788-1642-5602-FCDE-D291F0F7C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25F90D-F299-A7D9-4E76-7262443D07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87AF70-CD6C-D9A3-13FD-9D25B3687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3BA622-30AB-5769-8517-A3C9B635A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3E68B-5A4B-5B03-6771-019266F5B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52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B850C3-8E91-11CC-8B53-0A3242F6B1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A128E9-0286-5784-21E4-588B37FD29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A878A-F1C9-4344-6DF9-E0C8171CA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8A9077-45CE-04D9-A2FD-91B2BC8C0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ACA44C-B8F5-D8CC-675A-46EEA7FCE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805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31146D-943A-7236-60EF-A5AD68B71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80D597-17A3-7CBD-2457-658C90D8FF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D0479-6A67-8964-E697-C3346D19B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2F72C9-0E38-7C49-F3C1-04B94143F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972531-AEF0-340B-BCBC-0E8A774F1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888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ADC2B-8030-3097-AECD-C801C4150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AEC571-09EB-F6CF-23F8-E8E255DC2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C078E-A028-B74B-28F2-BCD2E219C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CAF624-18FB-8932-2866-F7D436816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EA6845-FED3-2A7A-64C8-DAC76ACB5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9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ADF76-01E8-3625-504F-E9A1036026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B53DAB-502D-F381-F5E5-972DF2DE47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8E78FA-031F-9162-5AF5-A0306A69A1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CA64FC-5F19-14DA-5916-76A5CA33A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73F5BB-63CE-76AB-6B11-407DB0363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E24FF8-64DF-50E1-4CA9-6519ED4E5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36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AFEF1-F18E-9A2F-84E3-3C660C44D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649F9D-F754-A86B-2ACB-175FABE620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947F4A-991B-F9CE-32C9-DE9F2D9B8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256623-6338-0462-C82E-A60B127884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21049B6-2214-9B59-1C3A-382AB88570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C641CF-5D83-32D3-ED17-788BC33FF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442F3E-6452-BDA9-4F8E-388552BFF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F15C90-1FD6-0F9C-636A-69643D48C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84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4CDB9B-3870-B666-3049-9D4D4276BA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C9A724-D74C-2B03-5C23-35DA5C5EC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7BFB89-5BB6-7E49-5EA5-BB928A586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BA5328-F73F-9F44-A447-454220F3D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251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04D264-E614-8744-8A50-59B2F4220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6C8001-390F-6A19-2C50-B3516959B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3468A9-D303-1016-DC10-82E4BE36B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751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09F50-3C7F-864A-0A0D-CBB0023694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832D05-2DBE-5C86-8B90-6F6E19D6A1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70122E-85B9-C7DD-A466-08482CD10B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0EBF88-9794-A460-4AA5-8DCAD1062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64E231-7629-4C51-8C28-B85E45E83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EC66B7-C9C2-03E5-18C8-212F2E940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498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9F019-65C9-9DA0-4DCC-751DC8039A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BFEA63-2F72-77DB-8771-1C0561447D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ED0974-25B7-FD1F-D406-8D781ED300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3A2711-0CDC-9F87-1859-378336928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3294E4-F03E-FB55-5F8D-0F79E0336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5BC92C-BD9E-2456-2462-5395DFD82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045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77AAFC-B6A5-7D78-5F9F-5BCDEA4B15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C2C3CE-E7D7-13F4-9F1F-165F93B1E4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9ACB2-2156-60B8-FF6E-3736F8B9A9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CEBC79-3747-419F-ABE3-6B47ABEC1F80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CCC500-7D20-D38E-B570-8115A141AD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66BAE-6939-27A1-A3F3-527C7D674B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6FB9D-5236-4EE7-AB86-7AD5E4743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570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E780C-8F91-678E-E239-8F0A387B0BF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11F40E-1C9D-9AD1-49F0-6D07772737C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85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0BB8F52-FD98-5F6A-A912-CF077FBD98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5675" y="120001"/>
            <a:ext cx="7630004" cy="66179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B853FFD-E945-2109-7594-A63E6A70869B}"/>
              </a:ext>
            </a:extLst>
          </p:cNvPr>
          <p:cNvSpPr txBox="1"/>
          <p:nvPr/>
        </p:nvSpPr>
        <p:spPr>
          <a:xfrm>
            <a:off x="323850" y="89535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A2693E-554D-0884-81FA-FD3D39267CF7}"/>
              </a:ext>
            </a:extLst>
          </p:cNvPr>
          <p:cNvSpPr txBox="1"/>
          <p:nvPr/>
        </p:nvSpPr>
        <p:spPr>
          <a:xfrm>
            <a:off x="447676" y="1990724"/>
            <a:ext cx="21624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portant genes to determine Dose according to Elastic Net model</a:t>
            </a:r>
          </a:p>
        </p:txBody>
      </p:sp>
    </p:spTree>
    <p:extLst>
      <p:ext uri="{BB962C8B-B14F-4D97-AF65-F5344CB8AC3E}">
        <p14:creationId xmlns:p14="http://schemas.microsoft.com/office/powerpoint/2010/main" val="688442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3A785A4-9FFF-0B7E-18D7-4A342381FA5D}"/>
              </a:ext>
            </a:extLst>
          </p:cNvPr>
          <p:cNvSpPr txBox="1"/>
          <p:nvPr/>
        </p:nvSpPr>
        <p:spPr>
          <a:xfrm>
            <a:off x="3321651" y="395416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1ED8AA3-2A51-D784-5899-536D83F182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1442"/>
          <a:stretch/>
        </p:blipFill>
        <p:spPr>
          <a:xfrm>
            <a:off x="2795053" y="963827"/>
            <a:ext cx="3409217" cy="53875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B2F8B20-0F8C-3C51-68B4-0ABCB93EE2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70027" y="710513"/>
            <a:ext cx="2930084" cy="589417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BA47820-3718-72FF-78A1-DDD187B287A5}"/>
              </a:ext>
            </a:extLst>
          </p:cNvPr>
          <p:cNvSpPr txBox="1"/>
          <p:nvPr/>
        </p:nvSpPr>
        <p:spPr>
          <a:xfrm>
            <a:off x="5235661" y="26084"/>
            <a:ext cx="17206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rvival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AF1F61-6977-D85F-F1DB-EB0DC6FE4D67}"/>
              </a:ext>
            </a:extLst>
          </p:cNvPr>
          <p:cNvSpPr txBox="1"/>
          <p:nvPr/>
        </p:nvSpPr>
        <p:spPr>
          <a:xfrm>
            <a:off x="8204690" y="302741"/>
            <a:ext cx="865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2A962D-95A7-10EE-9DDD-C29FF00072F3}"/>
              </a:ext>
            </a:extLst>
          </p:cNvPr>
          <p:cNvSpPr txBox="1"/>
          <p:nvPr/>
        </p:nvSpPr>
        <p:spPr>
          <a:xfrm>
            <a:off x="390525" y="2400300"/>
            <a:ext cx="180136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portant genes to determine survival according to gender using the Elastic Net model for Male and Fema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C6E059C-6036-5979-BC17-1091447D9D75}"/>
              </a:ext>
            </a:extLst>
          </p:cNvPr>
          <p:cNvSpPr txBox="1"/>
          <p:nvPr/>
        </p:nvSpPr>
        <p:spPr>
          <a:xfrm>
            <a:off x="148073" y="116205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507836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5CFBBBF-17A0-1AED-8874-FC370F14AAAA}"/>
              </a:ext>
            </a:extLst>
          </p:cNvPr>
          <p:cNvSpPr txBox="1"/>
          <p:nvPr/>
        </p:nvSpPr>
        <p:spPr>
          <a:xfrm>
            <a:off x="7025920" y="41807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B5CC707-5034-0DF3-BA52-A8A424B062D3}"/>
              </a:ext>
            </a:extLst>
          </p:cNvPr>
          <p:cNvSpPr txBox="1"/>
          <p:nvPr/>
        </p:nvSpPr>
        <p:spPr>
          <a:xfrm>
            <a:off x="4505324" y="418074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CA4824-6C15-7734-8013-8C350305D8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0901"/>
          <a:stretch/>
        </p:blipFill>
        <p:spPr>
          <a:xfrm>
            <a:off x="3343274" y="1135451"/>
            <a:ext cx="3409217" cy="542461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9845661-A778-5D0E-E2D8-25EFBD7FED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0901"/>
          <a:stretch/>
        </p:blipFill>
        <p:spPr>
          <a:xfrm>
            <a:off x="7517651" y="1135451"/>
            <a:ext cx="3409217" cy="54246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F61B944-39E9-3FBE-3C38-33DBBE799202}"/>
              </a:ext>
            </a:extLst>
          </p:cNvPr>
          <p:cNvSpPr txBox="1"/>
          <p:nvPr/>
        </p:nvSpPr>
        <p:spPr>
          <a:xfrm>
            <a:off x="9012193" y="418074"/>
            <a:ext cx="865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e</a:t>
            </a:r>
            <a:r>
              <a:rPr lang="en-US" dirty="0"/>
              <a:t>m</a:t>
            </a:r>
            <a:r>
              <a:rPr lang="en-US"/>
              <a:t>ale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6E066F-CC2E-724E-F9DD-8B26DC12B6AA}"/>
              </a:ext>
            </a:extLst>
          </p:cNvPr>
          <p:cNvSpPr txBox="1"/>
          <p:nvPr/>
        </p:nvSpPr>
        <p:spPr>
          <a:xfrm>
            <a:off x="291847" y="1223319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54954E-714B-C971-A6BB-D33B000B0ED5}"/>
              </a:ext>
            </a:extLst>
          </p:cNvPr>
          <p:cNvSpPr txBox="1"/>
          <p:nvPr/>
        </p:nvSpPr>
        <p:spPr>
          <a:xfrm>
            <a:off x="666750" y="1981200"/>
            <a:ext cx="208597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portant genes to predict pleural effusion in Male and Female NHPs using the Elastic Net Model</a:t>
            </a:r>
          </a:p>
        </p:txBody>
      </p:sp>
    </p:spTree>
    <p:extLst>
      <p:ext uri="{BB962C8B-B14F-4D97-AF65-F5344CB8AC3E}">
        <p14:creationId xmlns:p14="http://schemas.microsoft.com/office/powerpoint/2010/main" val="2279333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726</TotalTime>
  <Words>60</Words>
  <Application>Microsoft Office PowerPoint</Application>
  <PresentationFormat>Widescreen</PresentationFormat>
  <Paragraphs>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l Figure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Bylicky, Michelle (NIH/NCI) [E]</dc:creator>
  <cp:lastModifiedBy>Bylicky, Michelle (NIH/NCI) [E]</cp:lastModifiedBy>
  <cp:revision>5</cp:revision>
  <dcterms:created xsi:type="dcterms:W3CDTF">2024-03-19T16:40:25Z</dcterms:created>
  <dcterms:modified xsi:type="dcterms:W3CDTF">2024-07-22T14:38:38Z</dcterms:modified>
</cp:coreProperties>
</file>